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68"/>
  </p:normalViewPr>
  <p:slideViewPr>
    <p:cSldViewPr snapToGrid="0">
      <p:cViewPr varScale="1">
        <p:scale>
          <a:sx n="74" d="100"/>
          <a:sy n="74" d="100"/>
        </p:scale>
        <p:origin x="450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5" indent="0" algn="ctr">
              <a:buNone/>
              <a:defRPr sz="1500"/>
            </a:lvl2pPr>
            <a:lvl3pPr marL="685808" indent="0" algn="ctr">
              <a:buNone/>
              <a:defRPr sz="1350"/>
            </a:lvl3pPr>
            <a:lvl4pPr marL="1028713" indent="0" algn="ctr">
              <a:buNone/>
              <a:defRPr sz="1200"/>
            </a:lvl4pPr>
            <a:lvl5pPr marL="1371617" indent="0" algn="ctr">
              <a:buNone/>
              <a:defRPr sz="1200"/>
            </a:lvl5pPr>
            <a:lvl6pPr marL="1714521" indent="0" algn="ctr">
              <a:buNone/>
              <a:defRPr sz="1200"/>
            </a:lvl6pPr>
            <a:lvl7pPr marL="2057426" indent="0" algn="ctr">
              <a:buNone/>
              <a:defRPr sz="1200"/>
            </a:lvl7pPr>
            <a:lvl8pPr marL="2400330" indent="0" algn="ctr">
              <a:buNone/>
              <a:defRPr sz="1200"/>
            </a:lvl8pPr>
            <a:lvl9pPr marL="2743234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D5776-2ADE-4A18-9538-5704DBD2F497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F3653-8F80-4F47-911E-CA9F1CB28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641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D5776-2ADE-4A18-9538-5704DBD2F497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F3653-8F80-4F47-911E-CA9F1CB28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3994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D5776-2ADE-4A18-9538-5704DBD2F497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F3653-8F80-4F47-911E-CA9F1CB28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150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D5776-2ADE-4A18-9538-5704DBD2F497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F3653-8F80-4F47-911E-CA9F1CB28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4202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8159050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8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1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1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2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2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3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D5776-2ADE-4A18-9538-5704DBD2F497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F3653-8F80-4F47-911E-CA9F1CB28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808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D5776-2ADE-4A18-9538-5704DBD2F497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F3653-8F80-4F47-911E-CA9F1CB28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56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6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4453468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68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D5776-2ADE-4A18-9538-5704DBD2F497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F3653-8F80-4F47-911E-CA9F1CB28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34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D5776-2ADE-4A18-9538-5704DBD2F497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F3653-8F80-4F47-911E-CA9F1CB28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087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D5776-2ADE-4A18-9538-5704DBD2F497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F3653-8F80-4F47-911E-CA9F1CB28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812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755427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D5776-2ADE-4A18-9538-5704DBD2F497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F3653-8F80-4F47-911E-CA9F1CB28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023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755427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5" indent="0">
              <a:buNone/>
              <a:defRPr sz="2100"/>
            </a:lvl2pPr>
            <a:lvl3pPr marL="685808" indent="0">
              <a:buNone/>
              <a:defRPr sz="1800"/>
            </a:lvl3pPr>
            <a:lvl4pPr marL="1028713" indent="0">
              <a:buNone/>
              <a:defRPr sz="1500"/>
            </a:lvl4pPr>
            <a:lvl5pPr marL="1371617" indent="0">
              <a:buNone/>
              <a:defRPr sz="1500"/>
            </a:lvl5pPr>
            <a:lvl6pPr marL="1714521" indent="0">
              <a:buNone/>
              <a:defRPr sz="1500"/>
            </a:lvl6pPr>
            <a:lvl7pPr marL="2057426" indent="0">
              <a:buNone/>
              <a:defRPr sz="1500"/>
            </a:lvl7pPr>
            <a:lvl8pPr marL="2400330" indent="0">
              <a:buNone/>
              <a:defRPr sz="1500"/>
            </a:lvl8pPr>
            <a:lvl9pPr marL="2743234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D5776-2ADE-4A18-9538-5704DBD2F497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F3653-8F80-4F47-911E-CA9F1CB28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044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649116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AD5776-2ADE-4A18-9538-5704DBD2F497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11300182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6F3653-8F80-4F47-911E-CA9F1CB28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814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8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2" indent="-171452" algn="l" defTabSz="685808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6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61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65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69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74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78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82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87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5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8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13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17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21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26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30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34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795D1867-9203-402A-8E7F-1CA194EA73C7}"/>
              </a:ext>
            </a:extLst>
          </p:cNvPr>
          <p:cNvSpPr txBox="1"/>
          <p:nvPr/>
        </p:nvSpPr>
        <p:spPr>
          <a:xfrm>
            <a:off x="465220" y="10914674"/>
            <a:ext cx="6208295" cy="375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tabLst>
                <a:tab pos="793135" algn="l"/>
              </a:tabLst>
            </a:pP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3A0CD56-2AB8-4E02-851F-EEAD102EC83E}"/>
              </a:ext>
            </a:extLst>
          </p:cNvPr>
          <p:cNvSpPr txBox="1"/>
          <p:nvPr/>
        </p:nvSpPr>
        <p:spPr>
          <a:xfrm>
            <a:off x="219076" y="8893315"/>
            <a:ext cx="6454439" cy="6752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ry FIGURE 2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conserved motif of OrBTB genes was identified by the MEME tool. Colored rectangular boxes represent conserved motifs. Sequences of the 10 conserved motifs are shown in the figure legend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3080BA9-9401-983B-BA00-D7452AE969E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6947" b="13795"/>
          <a:stretch/>
        </p:blipFill>
        <p:spPr bwMode="auto">
          <a:xfrm>
            <a:off x="889424" y="631823"/>
            <a:ext cx="2875398" cy="73844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9FEFDFA-F7E0-9098-9362-1B9F43A5F85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14889" r="37483"/>
          <a:stretch>
            <a:fillRect/>
          </a:stretch>
        </p:blipFill>
        <p:spPr bwMode="auto">
          <a:xfrm>
            <a:off x="3942630" y="631821"/>
            <a:ext cx="2381970" cy="75459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3837948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5418651c-0681-43d7-868b-1c90920dbb03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64CF1D3472D484F8E3C8E423AA3B556" ma:contentTypeVersion="12" ma:contentTypeDescription="Create a new document." ma:contentTypeScope="" ma:versionID="a39ac3f3581b14c11d87d381711ebb43">
  <xsd:schema xmlns:xsd="http://www.w3.org/2001/XMLSchema" xmlns:xs="http://www.w3.org/2001/XMLSchema" xmlns:p="http://schemas.microsoft.com/office/2006/metadata/properties" xmlns:ns3="5418651c-0681-43d7-868b-1c90920dbb03" targetNamespace="http://schemas.microsoft.com/office/2006/metadata/properties" ma:root="true" ma:fieldsID="aef970670382c4a46f94ff6e8d109c12" ns3:_="">
    <xsd:import namespace="5418651c-0681-43d7-868b-1c90920dbb0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LengthInSeconds" minOccurs="0"/>
                <xsd:element ref="ns3:MediaServiceLocation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418651c-0681-43d7-868b-1c90920dbb0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_activity" ma:index="19" nillable="true" ma:displayName="_activity" ma:hidden="true" ma:internalName="_activity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EFF0E87-3B06-460E-9496-A681747A2B88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E0C34671-9A5E-4DB8-8322-E5D90F9517ED}">
  <ds:schemaRefs>
    <ds:schemaRef ds:uri="5418651c-0681-43d7-868b-1c90920dbb03"/>
    <ds:schemaRef ds:uri="http://schemas.microsoft.com/office/2006/documentManagement/types"/>
    <ds:schemaRef ds:uri="http://purl.org/dc/elements/1.1/"/>
    <ds:schemaRef ds:uri="http://schemas.openxmlformats.org/package/2006/metadata/core-properties"/>
    <ds:schemaRef ds:uri="http://www.w3.org/XML/1998/namespace"/>
    <ds:schemaRef ds:uri="http://schemas.microsoft.com/office/2006/metadata/properties"/>
    <ds:schemaRef ds:uri="http://schemas.microsoft.com/office/infopath/2007/PartnerControls"/>
    <ds:schemaRef ds:uri="http://purl.org/dc/dcmitype/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B1D0B387-00D1-4796-9DF7-5D4CDAEE7CF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418651c-0681-43d7-868b-1c90920dbb0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</TotalTime>
  <Words>3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dal, Swarupa</dc:creator>
  <cp:lastModifiedBy>Reyes, Benildo</cp:lastModifiedBy>
  <cp:revision>4</cp:revision>
  <dcterms:created xsi:type="dcterms:W3CDTF">2022-04-12T22:04:25Z</dcterms:created>
  <dcterms:modified xsi:type="dcterms:W3CDTF">2023-07-11T14:28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64CF1D3472D484F8E3C8E423AA3B556</vt:lpwstr>
  </property>
</Properties>
</file>